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745"/>
    <p:restoredTop sz="94696"/>
  </p:normalViewPr>
  <p:slideViewPr>
    <p:cSldViewPr>
      <p:cViewPr varScale="1">
        <p:scale>
          <a:sx n="84" d="100"/>
          <a:sy n="84" d="100"/>
        </p:scale>
        <p:origin x="1026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campus.unibe.ch\vet-home\buers\Dokumente\Mbovis\writing\BoMac_Nina\171025%20growth%20curve%20spent%20BoMac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3919409559316293E-2"/>
          <c:y val="0.12878472222222201"/>
          <c:w val="0.67236117409926899"/>
          <c:h val="0.71703712817147902"/>
        </c:manualLayout>
      </c:layout>
      <c:lineChart>
        <c:grouping val="standard"/>
        <c:varyColors val="0"/>
        <c:ser>
          <c:idx val="2"/>
          <c:order val="2"/>
          <c:tx>
            <c:strRef>
              <c:f>triplicates!$O$2</c:f>
              <c:strCache>
                <c:ptCount val="1"/>
                <c:pt idx="0">
                  <c:v>MEM-Earle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triplicates!$O$11:$O$15</c:f>
                <c:numCache>
                  <c:formatCode>General</c:formatCode>
                  <c:ptCount val="5"/>
                  <c:pt idx="0">
                    <c:v>0.22177742595654901</c:v>
                  </c:pt>
                  <c:pt idx="1">
                    <c:v>0.46468371865291003</c:v>
                  </c:pt>
                  <c:pt idx="2">
                    <c:v>0.42793545105268799</c:v>
                  </c:pt>
                  <c:pt idx="3">
                    <c:v>0.24021875410615701</c:v>
                  </c:pt>
                  <c:pt idx="4">
                    <c:v>0.186933976197526</c:v>
                  </c:pt>
                </c:numCache>
              </c:numRef>
            </c:plus>
            <c:minus>
              <c:numRef>
                <c:f>triplicates!$O$11:$O$15</c:f>
                <c:numCache>
                  <c:formatCode>General</c:formatCode>
                  <c:ptCount val="5"/>
                  <c:pt idx="0">
                    <c:v>0.22177742595654901</c:v>
                  </c:pt>
                  <c:pt idx="1">
                    <c:v>0.46468371865291003</c:v>
                  </c:pt>
                  <c:pt idx="2">
                    <c:v>0.42793545105268799</c:v>
                  </c:pt>
                  <c:pt idx="3">
                    <c:v>0.24021875410615701</c:v>
                  </c:pt>
                  <c:pt idx="4">
                    <c:v>0.1869339761975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riplicates!$M$3:$M$7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24</c:v>
                </c:pt>
                <c:pt idx="3">
                  <c:v>54</c:v>
                </c:pt>
                <c:pt idx="4">
                  <c:v>72</c:v>
                </c:pt>
              </c:numCache>
            </c:numRef>
          </c:cat>
          <c:val>
            <c:numRef>
              <c:f>triplicates!$O$3:$O$7</c:f>
              <c:numCache>
                <c:formatCode>General</c:formatCode>
                <c:ptCount val="5"/>
                <c:pt idx="0">
                  <c:v>5.4074693254472299</c:v>
                </c:pt>
                <c:pt idx="1">
                  <c:v>5.5346693088742001</c:v>
                </c:pt>
                <c:pt idx="2">
                  <c:v>5.2986228050477058</c:v>
                </c:pt>
                <c:pt idx="3">
                  <c:v>3.857054616409163</c:v>
                </c:pt>
                <c:pt idx="4">
                  <c:v>2.868912788063382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D5DD-41DB-92E6-BDDDAA4C264A}"/>
            </c:ext>
          </c:extLst>
        </c:ser>
        <c:ser>
          <c:idx val="4"/>
          <c:order val="4"/>
          <c:tx>
            <c:strRef>
              <c:f>triplicates!$Q$2</c:f>
              <c:strCache>
                <c:ptCount val="1"/>
                <c:pt idx="0">
                  <c:v>48 hours spent medium Bomac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x"/>
            <c:size val="5"/>
            <c:spPr>
              <a:noFill/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triplicates!$Q$11:$Q$15</c:f>
                <c:numCache>
                  <c:formatCode>General</c:formatCode>
                  <c:ptCount val="5"/>
                  <c:pt idx="0">
                    <c:v>0.38473690095804702</c:v>
                  </c:pt>
                  <c:pt idx="1">
                    <c:v>0.205612058714531</c:v>
                  </c:pt>
                  <c:pt idx="2">
                    <c:v>5.6121486644273397E-2</c:v>
                  </c:pt>
                  <c:pt idx="3">
                    <c:v>0.42871934866790201</c:v>
                  </c:pt>
                  <c:pt idx="4">
                    <c:v>0.335082769076538</c:v>
                  </c:pt>
                </c:numCache>
              </c:numRef>
            </c:plus>
            <c:minus>
              <c:numRef>
                <c:f>triplicates!$Q$11:$Q$15</c:f>
                <c:numCache>
                  <c:formatCode>General</c:formatCode>
                  <c:ptCount val="5"/>
                  <c:pt idx="0">
                    <c:v>0.38473690095804702</c:v>
                  </c:pt>
                  <c:pt idx="1">
                    <c:v>0.205612058714531</c:v>
                  </c:pt>
                  <c:pt idx="2">
                    <c:v>5.6121486644273397E-2</c:v>
                  </c:pt>
                  <c:pt idx="3">
                    <c:v>0.42871934866790201</c:v>
                  </c:pt>
                  <c:pt idx="4">
                    <c:v>0.3350827690765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riplicates!$M$3:$M$7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24</c:v>
                </c:pt>
                <c:pt idx="3">
                  <c:v>54</c:v>
                </c:pt>
                <c:pt idx="4">
                  <c:v>72</c:v>
                </c:pt>
              </c:numCache>
            </c:numRef>
          </c:cat>
          <c:val>
            <c:numRef>
              <c:f>triplicates!$Q$3:$Q$7</c:f>
              <c:numCache>
                <c:formatCode>General</c:formatCode>
                <c:ptCount val="5"/>
                <c:pt idx="0">
                  <c:v>5.8848339283598676</c:v>
                </c:pt>
                <c:pt idx="1">
                  <c:v>6.4745517681194356</c:v>
                </c:pt>
                <c:pt idx="2">
                  <c:v>6.3949097483544657</c:v>
                </c:pt>
                <c:pt idx="3">
                  <c:v>5.4249547945783316</c:v>
                </c:pt>
                <c:pt idx="4">
                  <c:v>4.72158593796842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5DD-41DB-92E6-BDDDAA4C264A}"/>
            </c:ext>
          </c:extLst>
        </c:ser>
        <c:ser>
          <c:idx val="6"/>
          <c:order val="6"/>
          <c:tx>
            <c:strRef>
              <c:f>triplicates!$S$2</c:f>
              <c:strCache>
                <c:ptCount val="1"/>
                <c:pt idx="0">
                  <c:v>24 hours spent medium Bomac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lgDash"/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triplicates!$S$11:$S$15</c:f>
                <c:numCache>
                  <c:formatCode>General</c:formatCode>
                  <c:ptCount val="5"/>
                  <c:pt idx="0">
                    <c:v>0.41591045639447899</c:v>
                  </c:pt>
                  <c:pt idx="1">
                    <c:v>0.20122253979777199</c:v>
                  </c:pt>
                  <c:pt idx="2">
                    <c:v>6.2638795140840697E-2</c:v>
                  </c:pt>
                  <c:pt idx="3">
                    <c:v>0.185421234372598</c:v>
                  </c:pt>
                  <c:pt idx="4">
                    <c:v>0.31938867309077301</c:v>
                  </c:pt>
                </c:numCache>
              </c:numRef>
            </c:plus>
            <c:minus>
              <c:numRef>
                <c:f>triplicates!$S$11:$S$15</c:f>
                <c:numCache>
                  <c:formatCode>General</c:formatCode>
                  <c:ptCount val="5"/>
                  <c:pt idx="0">
                    <c:v>0.41591045639447899</c:v>
                  </c:pt>
                  <c:pt idx="1">
                    <c:v>0.20122253979777199</c:v>
                  </c:pt>
                  <c:pt idx="2">
                    <c:v>6.2638795140840697E-2</c:v>
                  </c:pt>
                  <c:pt idx="3">
                    <c:v>0.185421234372598</c:v>
                  </c:pt>
                  <c:pt idx="4">
                    <c:v>0.319388673090773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riplicates!$M$3:$M$7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24</c:v>
                </c:pt>
                <c:pt idx="3">
                  <c:v>54</c:v>
                </c:pt>
                <c:pt idx="4">
                  <c:v>72</c:v>
                </c:pt>
              </c:numCache>
            </c:numRef>
          </c:cat>
          <c:val>
            <c:numRef>
              <c:f>triplicates!$S$3:$S$7</c:f>
              <c:numCache>
                <c:formatCode>General</c:formatCode>
                <c:ptCount val="5"/>
                <c:pt idx="0">
                  <c:v>5.7419540811373322</c:v>
                </c:pt>
                <c:pt idx="1">
                  <c:v>6.6270596597513753</c:v>
                </c:pt>
                <c:pt idx="2">
                  <c:v>6.6887990914304369</c:v>
                </c:pt>
                <c:pt idx="3">
                  <c:v>5.717245938488678</c:v>
                </c:pt>
                <c:pt idx="4">
                  <c:v>4.904734738706978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D5DD-41DB-92E6-BDDDAA4C264A}"/>
            </c:ext>
          </c:extLst>
        </c:ser>
        <c:ser>
          <c:idx val="8"/>
          <c:order val="8"/>
          <c:tx>
            <c:strRef>
              <c:f>triplicates!$U$2</c:f>
              <c:strCache>
                <c:ptCount val="1"/>
                <c:pt idx="0">
                  <c:v>48 hours spent medium Bomac + BVDV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triplicates!$U$11:$U$15</c:f>
                <c:numCache>
                  <c:formatCode>General</c:formatCode>
                  <c:ptCount val="5"/>
                  <c:pt idx="0">
                    <c:v>0.44846131676242701</c:v>
                  </c:pt>
                  <c:pt idx="1">
                    <c:v>0.19690177242287299</c:v>
                  </c:pt>
                  <c:pt idx="2">
                    <c:v>8.9509688386685604E-2</c:v>
                  </c:pt>
                  <c:pt idx="3">
                    <c:v>9.6440781185236996E-2</c:v>
                  </c:pt>
                  <c:pt idx="4">
                    <c:v>0.12575653638405401</c:v>
                  </c:pt>
                </c:numCache>
              </c:numRef>
            </c:plus>
            <c:minus>
              <c:numRef>
                <c:f>triplicates!$U$11:$U$15</c:f>
                <c:numCache>
                  <c:formatCode>General</c:formatCode>
                  <c:ptCount val="5"/>
                  <c:pt idx="0">
                    <c:v>0.44846131676242701</c:v>
                  </c:pt>
                  <c:pt idx="1">
                    <c:v>0.19690177242287299</c:v>
                  </c:pt>
                  <c:pt idx="2">
                    <c:v>8.9509688386685604E-2</c:v>
                  </c:pt>
                  <c:pt idx="3">
                    <c:v>9.6440781185236996E-2</c:v>
                  </c:pt>
                  <c:pt idx="4">
                    <c:v>0.125756536384054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riplicates!$M$3:$M$7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24</c:v>
                </c:pt>
                <c:pt idx="3">
                  <c:v>54</c:v>
                </c:pt>
                <c:pt idx="4">
                  <c:v>72</c:v>
                </c:pt>
              </c:numCache>
            </c:numRef>
          </c:cat>
          <c:val>
            <c:numRef>
              <c:f>triplicates!$U$3:$U$7</c:f>
              <c:numCache>
                <c:formatCode>General</c:formatCode>
                <c:ptCount val="5"/>
                <c:pt idx="0">
                  <c:v>5.6836727273812437</c:v>
                </c:pt>
                <c:pt idx="1">
                  <c:v>6.5766506367468809</c:v>
                </c:pt>
                <c:pt idx="2">
                  <c:v>6.5948403876304464</c:v>
                </c:pt>
                <c:pt idx="3">
                  <c:v>5.6913342676407757</c:v>
                </c:pt>
                <c:pt idx="4">
                  <c:v>4.9090093757935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D5DD-41DB-92E6-BDDDAA4C264A}"/>
            </c:ext>
          </c:extLst>
        </c:ser>
        <c:ser>
          <c:idx val="10"/>
          <c:order val="10"/>
          <c:tx>
            <c:strRef>
              <c:f>triplicates!$W$2</c:f>
              <c:strCache>
                <c:ptCount val="1"/>
                <c:pt idx="0">
                  <c:v>24 hours spent medium Bomac + BVDV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triplicates!$W$11:$W$15</c:f>
                <c:numCache>
                  <c:formatCode>General</c:formatCode>
                  <c:ptCount val="5"/>
                  <c:pt idx="0">
                    <c:v>0.56016626508079004</c:v>
                  </c:pt>
                  <c:pt idx="1">
                    <c:v>0.18243529437765499</c:v>
                  </c:pt>
                  <c:pt idx="2">
                    <c:v>9.1651873761880401E-2</c:v>
                  </c:pt>
                  <c:pt idx="3">
                    <c:v>0.109112290133301</c:v>
                  </c:pt>
                  <c:pt idx="4">
                    <c:v>0.11410827264242999</c:v>
                  </c:pt>
                </c:numCache>
              </c:numRef>
            </c:plus>
            <c:minus>
              <c:numRef>
                <c:f>triplicates!$W$11:$W$15</c:f>
                <c:numCache>
                  <c:formatCode>General</c:formatCode>
                  <c:ptCount val="5"/>
                  <c:pt idx="0">
                    <c:v>0.56016626508079004</c:v>
                  </c:pt>
                  <c:pt idx="1">
                    <c:v>0.18243529437765499</c:v>
                  </c:pt>
                  <c:pt idx="2">
                    <c:v>9.1651873761880401E-2</c:v>
                  </c:pt>
                  <c:pt idx="3">
                    <c:v>0.109112290133301</c:v>
                  </c:pt>
                  <c:pt idx="4">
                    <c:v>0.11410827264242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riplicates!$M$3:$M$7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24</c:v>
                </c:pt>
                <c:pt idx="3">
                  <c:v>54</c:v>
                </c:pt>
                <c:pt idx="4">
                  <c:v>72</c:v>
                </c:pt>
              </c:numCache>
            </c:numRef>
          </c:cat>
          <c:val>
            <c:numRef>
              <c:f>triplicates!$W$3:$W$7</c:f>
              <c:numCache>
                <c:formatCode>General</c:formatCode>
                <c:ptCount val="5"/>
                <c:pt idx="0">
                  <c:v>5.8117053773847456</c:v>
                </c:pt>
                <c:pt idx="1">
                  <c:v>6.5811089987045319</c:v>
                </c:pt>
                <c:pt idx="2">
                  <c:v>6.5972111441367884</c:v>
                </c:pt>
                <c:pt idx="3">
                  <c:v>5.645416371387836</c:v>
                </c:pt>
                <c:pt idx="4">
                  <c:v>4.812178445391822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D5DD-41DB-92E6-BDDDAA4C26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09310784"/>
        <c:axId val="324062848"/>
        <c:extLst xmlns:c16r2="http://schemas.microsoft.com/office/drawing/2015/06/chart"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 xmlns:c16r2="http://schemas.microsoft.com/office/drawing/2015/06/chart">
                      <c:ext uri="{02D57815-91ED-43cb-92C2-25804820EDAC}">
                        <c15:formulaRef>
                          <c15:sqref>triplicates!$M$2</c15:sqref>
                        </c15:formulaRef>
                      </c:ext>
                    </c:extLst>
                    <c:strCache>
                      <c:ptCount val="1"/>
                      <c:pt idx="0">
                        <c:v>log10 CFU/ml</c:v>
                      </c:pt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cat>
                  <c:numRef>
                    <c:extLst xmlns:c16r2="http://schemas.microsoft.com/office/drawing/2015/06/chart">
                      <c:ext uri="{02D57815-91ED-43cb-92C2-25804820EDAC}">
                        <c15:formulaRef>
                          <c15:sqref>triplicates!$M$3:$M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6</c:v>
                      </c:pt>
                      <c:pt idx="2">
                        <c:v>24</c:v>
                      </c:pt>
                      <c:pt idx="3">
                        <c:v>54</c:v>
                      </c:pt>
                      <c:pt idx="4">
                        <c:v>72</c:v>
                      </c:pt>
                    </c:numCache>
                  </c:numRef>
                </c:cat>
                <c:val>
                  <c:numRef>
                    <c:extLst xmlns:c16r2="http://schemas.microsoft.com/office/drawing/2015/06/chart">
                      <c:ext uri="{02D57815-91ED-43cb-92C2-25804820EDAC}">
                        <c15:formulaRef>
                          <c15:sqref>triplicates!$M$3:$M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6</c:v>
                      </c:pt>
                      <c:pt idx="2">
                        <c:v>24</c:v>
                      </c:pt>
                      <c:pt idx="3">
                        <c:v>54</c:v>
                      </c:pt>
                      <c:pt idx="4">
                        <c:v>72</c:v>
                      </c:pt>
                    </c:numCache>
                  </c:numRef>
                </c:val>
                <c:smooth val="0"/>
                <c:extLst xmlns:c16r2="http://schemas.microsoft.com/office/drawing/2015/06/chart">
                  <c:ext xmlns:c16="http://schemas.microsoft.com/office/drawing/2014/chart" uri="{C3380CC4-5D6E-409C-BE32-E72D297353CC}">
                    <c16:uniqueId val="{00000005-D5DD-41DB-92E6-BDDDAA4C264A}"/>
                  </c:ext>
                </c:extLst>
              </c15:ser>
            </c15:filteredLineSeries>
            <c15:filteredLineSeries>
              <c15:ser>
                <c:idx val="1"/>
                <c:order val="1"/>
                <c:tx>
                  <c:str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N$2</c15:sqref>
                        </c15:formulaRef>
                      </c:ext>
                    </c:extLst>
                    <c:strCache>
                      <c:ptCount val="1"/>
                      <c:pt idx="0">
                        <c:v>MEM-Earle</c:v>
                      </c:pt>
                    </c:strCache>
                  </c:strRef>
                </c:tx>
                <c:spPr>
                  <a:ln w="28575" cap="rnd">
                    <a:solidFill>
                      <a:schemeClr val="accent2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/>
                    </a:solidFill>
                    <a:ln w="9525">
                      <a:solidFill>
                        <a:schemeClr val="accent2"/>
                      </a:solidFill>
                    </a:ln>
                    <a:effectLst/>
                  </c:spPr>
                </c:marker>
                <c:cat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M$3:$M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6</c:v>
                      </c:pt>
                      <c:pt idx="2">
                        <c:v>24</c:v>
                      </c:pt>
                      <c:pt idx="3">
                        <c:v>54</c:v>
                      </c:pt>
                      <c:pt idx="4">
                        <c:v>72</c:v>
                      </c:pt>
                    </c:numCache>
                  </c:numRef>
                </c:cat>
                <c:val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N$3:$N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5.0309830563886164</c:v>
                      </c:pt>
                      <c:pt idx="1">
                        <c:v>4.9221826284541477</c:v>
                      </c:pt>
                      <c:pt idx="2">
                        <c:v>3.9049200287670449</c:v>
                      </c:pt>
                      <c:pt idx="3">
                        <c:v>2.1786061136905182</c:v>
                      </c:pt>
                      <c:pt idx="4">
                        <c:v>0</c:v>
                      </c:pt>
                    </c:numCache>
                  </c:numRef>
                </c:val>
                <c:smooth val="0"/>
                <c:extLst xmlns:c15="http://schemas.microsoft.com/office/drawing/2012/chart" xmlns:c16r2="http://schemas.microsoft.com/office/drawing/2015/06/chart">
                  <c:ext xmlns:c16="http://schemas.microsoft.com/office/drawing/2014/chart" uri="{C3380CC4-5D6E-409C-BE32-E72D297353CC}">
                    <c16:uniqueId val="{00000006-D5DD-41DB-92E6-BDDDAA4C264A}"/>
                  </c:ext>
                </c:extLst>
              </c15:ser>
            </c15:filteredLineSeries>
            <c15:filteredLineSeries>
              <c15:ser>
                <c:idx val="3"/>
                <c:order val="3"/>
                <c:tx>
                  <c:str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P$2</c15:sqref>
                        </c15:formulaRef>
                      </c:ext>
                    </c:extLst>
                    <c:strCache>
                      <c:ptCount val="1"/>
                      <c:pt idx="0">
                        <c:v>48 hours spent medium Bomac</c:v>
                      </c:pt>
                    </c:strCache>
                  </c:strRef>
                </c:tx>
                <c:spPr>
                  <a:ln w="28575" cap="rnd">
                    <a:solidFill>
                      <a:schemeClr val="accent4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4"/>
                    </a:solidFill>
                    <a:ln w="9525">
                      <a:solidFill>
                        <a:schemeClr val="accent4"/>
                      </a:solidFill>
                    </a:ln>
                    <a:effectLst/>
                  </c:spPr>
                </c:marker>
                <c:cat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M$3:$M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6</c:v>
                      </c:pt>
                      <c:pt idx="2">
                        <c:v>24</c:v>
                      </c:pt>
                      <c:pt idx="3">
                        <c:v>54</c:v>
                      </c:pt>
                      <c:pt idx="4">
                        <c:v>72</c:v>
                      </c:pt>
                    </c:numCache>
                  </c:numRef>
                </c:cat>
                <c:val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P$3:$P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4.8586255927194273</c:v>
                      </c:pt>
                      <c:pt idx="1">
                        <c:v>5.5574536164809452</c:v>
                      </c:pt>
                      <c:pt idx="2">
                        <c:v>6.6287142490553892</c:v>
                      </c:pt>
                      <c:pt idx="3">
                        <c:v>6.311719342739269</c:v>
                      </c:pt>
                      <c:pt idx="4">
                        <c:v>4.8119675042892824</c:v>
                      </c:pt>
                    </c:numCache>
                  </c:numRef>
                </c:val>
                <c:smooth val="0"/>
                <c:extLst xmlns:c15="http://schemas.microsoft.com/office/drawing/2012/chart" xmlns:c16r2="http://schemas.microsoft.com/office/drawing/2015/06/chart">
                  <c:ext xmlns:c16="http://schemas.microsoft.com/office/drawing/2014/chart" uri="{C3380CC4-5D6E-409C-BE32-E72D297353CC}">
                    <c16:uniqueId val="{00000007-D5DD-41DB-92E6-BDDDAA4C264A}"/>
                  </c:ext>
                </c:extLst>
              </c15:ser>
            </c15:filteredLineSeries>
            <c15:filteredLineSeries>
              <c15:ser>
                <c:idx val="5"/>
                <c:order val="5"/>
                <c:tx>
                  <c:str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R$2</c15:sqref>
                        </c15:formulaRef>
                      </c:ext>
                    </c:extLst>
                    <c:strCache>
                      <c:ptCount val="1"/>
                      <c:pt idx="0">
                        <c:v>24 hours spent medium Bomac</c:v>
                      </c:pt>
                    </c:strCache>
                  </c:strRef>
                </c:tx>
                <c:spPr>
                  <a:ln w="28575" cap="rnd">
                    <a:solidFill>
                      <a:schemeClr val="accent6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6"/>
                    </a:solidFill>
                    <a:ln w="9525">
                      <a:solidFill>
                        <a:schemeClr val="accent6"/>
                      </a:solidFill>
                    </a:ln>
                    <a:effectLst/>
                  </c:spPr>
                </c:marker>
                <c:cat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M$3:$M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6</c:v>
                      </c:pt>
                      <c:pt idx="2">
                        <c:v>24</c:v>
                      </c:pt>
                      <c:pt idx="3">
                        <c:v>54</c:v>
                      </c:pt>
                      <c:pt idx="4">
                        <c:v>72</c:v>
                      </c:pt>
                    </c:numCache>
                  </c:numRef>
                </c:cat>
                <c:val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R$3:$R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5.0770687716470002</c:v>
                      </c:pt>
                      <c:pt idx="1">
                        <c:v>5.5595574413447704</c:v>
                      </c:pt>
                      <c:pt idx="2">
                        <c:v>6.7749657134145806</c:v>
                      </c:pt>
                      <c:pt idx="3">
                        <c:v>6.4570216815134964</c:v>
                      </c:pt>
                      <c:pt idx="4">
                        <c:v>5.1473611332884301</c:v>
                      </c:pt>
                    </c:numCache>
                  </c:numRef>
                </c:val>
                <c:smooth val="0"/>
                <c:extLst xmlns:c15="http://schemas.microsoft.com/office/drawing/2012/chart" xmlns:c16r2="http://schemas.microsoft.com/office/drawing/2015/06/chart">
                  <c:ext xmlns:c16="http://schemas.microsoft.com/office/drawing/2014/chart" uri="{C3380CC4-5D6E-409C-BE32-E72D297353CC}">
                    <c16:uniqueId val="{00000008-D5DD-41DB-92E6-BDDDAA4C264A}"/>
                  </c:ext>
                </c:extLst>
              </c15:ser>
            </c15:filteredLineSeries>
            <c15:filteredLineSeries>
              <c15:ser>
                <c:idx val="7"/>
                <c:order val="7"/>
                <c:tx>
                  <c:str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T$2</c15:sqref>
                        </c15:formulaRef>
                      </c:ext>
                    </c:extLst>
                    <c:strCache>
                      <c:ptCount val="1"/>
                      <c:pt idx="0">
                        <c:v>48 hours spent medium Bomac + BVDV</c:v>
                      </c:pt>
                    </c:strCache>
                  </c:strRef>
                </c:tx>
                <c:spPr>
                  <a:ln w="28575" cap="rnd">
                    <a:solidFill>
                      <a:schemeClr val="accent2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>
                        <a:lumMod val="60000"/>
                      </a:schemeClr>
                    </a:solidFill>
                    <a:ln w="9525">
                      <a:solidFill>
                        <a:schemeClr val="accent2">
                          <a:lumMod val="60000"/>
                        </a:schemeClr>
                      </a:solidFill>
                    </a:ln>
                    <a:effectLst/>
                  </c:spPr>
                </c:marker>
                <c:cat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M$3:$M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6</c:v>
                      </c:pt>
                      <c:pt idx="2">
                        <c:v>24</c:v>
                      </c:pt>
                      <c:pt idx="3">
                        <c:v>54</c:v>
                      </c:pt>
                      <c:pt idx="4">
                        <c:v>72</c:v>
                      </c:pt>
                    </c:numCache>
                  </c:numRef>
                </c:cat>
                <c:val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T$3:$T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5.1126127338325063</c:v>
                      </c:pt>
                      <c:pt idx="1">
                        <c:v>5.58329837346521</c:v>
                      </c:pt>
                      <c:pt idx="2">
                        <c:v>6.7393106005120771</c:v>
                      </c:pt>
                      <c:pt idx="3">
                        <c:v>6.3551938351039201</c:v>
                      </c:pt>
                      <c:pt idx="4">
                        <c:v>4.8218353870828956</c:v>
                      </c:pt>
                    </c:numCache>
                  </c:numRef>
                </c:val>
                <c:smooth val="0"/>
                <c:extLst xmlns:c15="http://schemas.microsoft.com/office/drawing/2012/chart" xmlns:c16r2="http://schemas.microsoft.com/office/drawing/2015/06/chart">
                  <c:ext xmlns:c16="http://schemas.microsoft.com/office/drawing/2014/chart" uri="{C3380CC4-5D6E-409C-BE32-E72D297353CC}">
                    <c16:uniqueId val="{00000009-D5DD-41DB-92E6-BDDDAA4C264A}"/>
                  </c:ext>
                </c:extLst>
              </c15:ser>
            </c15:filteredLineSeries>
            <c15:filteredLineSeries>
              <c15:ser>
                <c:idx val="9"/>
                <c:order val="9"/>
                <c:tx>
                  <c:str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V$2</c15:sqref>
                        </c15:formulaRef>
                      </c:ext>
                    </c:extLst>
                    <c:strCache>
                      <c:ptCount val="1"/>
                      <c:pt idx="0">
                        <c:v>24 hours spent medium Bomac + BVDV</c:v>
                      </c:pt>
                    </c:strCache>
                  </c:strRef>
                </c:tx>
                <c:spPr>
                  <a:ln w="28575" cap="rnd">
                    <a:solidFill>
                      <a:schemeClr val="accent4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4">
                        <a:lumMod val="60000"/>
                      </a:schemeClr>
                    </a:solidFill>
                    <a:ln w="9525">
                      <a:solidFill>
                        <a:schemeClr val="accent4">
                          <a:lumMod val="60000"/>
                        </a:schemeClr>
                      </a:solidFill>
                    </a:ln>
                    <a:effectLst/>
                  </c:spPr>
                </c:marker>
                <c:cat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M$3:$M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6</c:v>
                      </c:pt>
                      <c:pt idx="2">
                        <c:v>24</c:v>
                      </c:pt>
                      <c:pt idx="3">
                        <c:v>54</c:v>
                      </c:pt>
                      <c:pt idx="4">
                        <c:v>72</c:v>
                      </c:pt>
                    </c:numCache>
                  </c:numRef>
                </c:cat>
                <c:val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V$3:$V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5.1020337127063149</c:v>
                      </c:pt>
                      <c:pt idx="1">
                        <c:v>5.6486538812752549</c:v>
                      </c:pt>
                      <c:pt idx="2">
                        <c:v>6.6823760772766869</c:v>
                      </c:pt>
                      <c:pt idx="3">
                        <c:v>6.1665054081041966</c:v>
                      </c:pt>
                      <c:pt idx="4">
                        <c:v>4.8768112458207353</c:v>
                      </c:pt>
                    </c:numCache>
                  </c:numRef>
                </c:val>
                <c:smooth val="0"/>
                <c:extLst xmlns:c15="http://schemas.microsoft.com/office/drawing/2012/chart" xmlns:c16r2="http://schemas.microsoft.com/office/drawing/2015/06/chart">
                  <c:ext xmlns:c16="http://schemas.microsoft.com/office/drawing/2014/chart" uri="{C3380CC4-5D6E-409C-BE32-E72D297353CC}">
                    <c16:uniqueId val="{0000000A-D5DD-41DB-92E6-BDDDAA4C264A}"/>
                  </c:ext>
                </c:extLst>
              </c15:ser>
            </c15:filteredLineSeries>
          </c:ext>
        </c:extLst>
      </c:lineChart>
      <c:dateAx>
        <c:axId val="3093107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sz="14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me </a:t>
                </a:r>
                <a:r>
                  <a:rPr lang="en-US" sz="14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hours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324062848"/>
        <c:crossesAt val="0"/>
        <c:auto val="0"/>
        <c:lblOffset val="100"/>
        <c:baseTimeUnit val="days"/>
        <c:majorUnit val="6"/>
        <c:majorTimeUnit val="days"/>
      </c:dateAx>
      <c:valAx>
        <c:axId val="3240628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10 (</a:t>
                </a:r>
                <a:r>
                  <a:rPr lang="en-US" sz="14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FU/mL)</a:t>
                </a:r>
                <a:endParaRPr lang="en-US" sz="14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3.8978332073570199E-3"/>
              <c:y val="0.33382448979591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3093107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4607671957671995"/>
          <c:y val="0.22166666666666701"/>
          <c:w val="0.24862940136381201"/>
          <c:h val="0.561636045494313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15774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712902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218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98210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366431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38662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62100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65926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72144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92669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951447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77255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651722"/>
              </p:ext>
            </p:extLst>
          </p:nvPr>
        </p:nvGraphicFramePr>
        <p:xfrm>
          <a:off x="594813" y="1224000"/>
          <a:ext cx="7938000" cy="44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3095687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</TotalTime>
  <Words>8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résentation PowerPoint</vt:lpstr>
    </vt:vector>
  </TitlesOfParts>
  <Company>VETSUISS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i, Christoph (VETSUISSE)</dc:creator>
  <cp:lastModifiedBy>ecoulamy</cp:lastModifiedBy>
  <cp:revision>14</cp:revision>
  <cp:lastPrinted>2017-11-06T14:50:12Z</cp:lastPrinted>
  <dcterms:created xsi:type="dcterms:W3CDTF">2017-11-06T10:40:48Z</dcterms:created>
  <dcterms:modified xsi:type="dcterms:W3CDTF">2017-12-18T14:04:03Z</dcterms:modified>
</cp:coreProperties>
</file>